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74514" autoAdjust="0"/>
  </p:normalViewPr>
  <p:slideViewPr>
    <p:cSldViewPr snapToGrid="0">
      <p:cViewPr varScale="1">
        <p:scale>
          <a:sx n="42" d="100"/>
          <a:sy n="42" d="100"/>
        </p:scale>
        <p:origin x="153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34CF48-9FEA-4246-8B23-4615317A41CF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0C4FB1-3691-494A-8453-47F02F6B7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8940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</a:t>
            </a:r>
            <a:r>
              <a:rPr lang="en-US" dirty="0"/>
              <a:t>Changes in Mental Health Visit Diagnoses in Primary Care Before and After Primary Care-Behavioral Health Integration Program by Sex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C4FB1-3691-494A-8453-47F02F6B71A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2177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</a:t>
            </a:r>
            <a:r>
              <a:rPr lang="en-US" dirty="0"/>
              <a:t>Changes in Mental Health Visit Diagnoses in Primary Care Before and After Primary Care-Behavioral Health Integration Program by Birth Cohort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C4FB1-3691-494A-8453-47F02F6B71A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7409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</a:t>
            </a:r>
            <a:r>
              <a:rPr lang="en-US" dirty="0"/>
              <a:t>Changes in Mental Health Visit Diagnoses in Primary Care Before and After Primary Care-Behavioral Health Integration Program by Race/Ethnicity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0C4FB1-3691-494A-8453-47F02F6B71A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7002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438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84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304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94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537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982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799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771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292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63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241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AE462-C9B1-4484-925F-A98E2C7E8B31}" type="datetimeFigureOut">
              <a:rPr lang="en-US" smtClean="0"/>
              <a:t>12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9FA88-4585-4BAC-94F2-4EC905F82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612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D39904A4-EA15-4746-9C0A-620A1D246EFE}"/>
              </a:ext>
            </a:extLst>
          </p:cNvPr>
          <p:cNvGrpSpPr/>
          <p:nvPr/>
        </p:nvGrpSpPr>
        <p:grpSpPr>
          <a:xfrm>
            <a:off x="366531" y="465880"/>
            <a:ext cx="10226403" cy="8383769"/>
            <a:chOff x="366531" y="465880"/>
            <a:chExt cx="10226403" cy="8383769"/>
          </a:xfrm>
        </p:grpSpPr>
        <p:sp>
          <p:nvSpPr>
            <p:cNvPr id="13" name="Rectangle 12"/>
            <p:cNvSpPr/>
            <p:nvPr/>
          </p:nvSpPr>
          <p:spPr>
            <a:xfrm>
              <a:off x="548979" y="465880"/>
              <a:ext cx="6096000" cy="36933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lvl="0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. Any Mental Health Condition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201924" y="6193907"/>
              <a:ext cx="363862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. Post-Traumatic Stress Disorder</a:t>
              </a:r>
              <a:endPara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6201924" y="3373650"/>
              <a:ext cx="43910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. Attention Deficit Hyperactivity Disorder</a:t>
              </a:r>
              <a:endPara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6201924" y="493210"/>
              <a:ext cx="199285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. Panic Disorder</a:t>
              </a:r>
              <a:endPara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690432" y="6204622"/>
              <a:ext cx="22750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. Anxiety Disorders</a:t>
              </a:r>
              <a:endPara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586121" y="3319274"/>
              <a:ext cx="163378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. Depression</a:t>
              </a:r>
              <a:endPara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5DBBE18-DD0A-4486-8730-34E27666E7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6531" y="987523"/>
              <a:ext cx="5035202" cy="2217174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99398E6-9B02-45FA-8F57-E53DC9B2819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5666" y="1017095"/>
              <a:ext cx="4914663" cy="214333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E0C823D-7BB0-4CD3-9A50-50C30A500D3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0210" y="3688406"/>
              <a:ext cx="5202256" cy="2217173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EC05EE3E-D2EA-4A1B-9E6D-713ADE7D638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5766" y="3893466"/>
              <a:ext cx="4744563" cy="2012113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5EF7D52E-74A9-4DE9-9EBB-7C0619F7071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0210" y="6632477"/>
              <a:ext cx="5130536" cy="2217172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4614C6D-9E54-47F7-81DE-DA93F7023DD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42217" y="6638678"/>
              <a:ext cx="4505119" cy="201211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68946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B617BA33-B8D0-4899-B411-461446680009}"/>
              </a:ext>
            </a:extLst>
          </p:cNvPr>
          <p:cNvGrpSpPr/>
          <p:nvPr/>
        </p:nvGrpSpPr>
        <p:grpSpPr>
          <a:xfrm>
            <a:off x="538263" y="471238"/>
            <a:ext cx="10054671" cy="8560378"/>
            <a:chOff x="538263" y="471238"/>
            <a:chExt cx="10054671" cy="8560378"/>
          </a:xfrm>
        </p:grpSpPr>
        <p:sp>
          <p:nvSpPr>
            <p:cNvPr id="13" name="Rectangle 12"/>
            <p:cNvSpPr/>
            <p:nvPr/>
          </p:nvSpPr>
          <p:spPr>
            <a:xfrm>
              <a:off x="986042" y="471238"/>
              <a:ext cx="6096000" cy="36933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lvl="0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. Any Mental Health Condition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201924" y="6193907"/>
              <a:ext cx="363862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. Post-Traumatic Stress Disorder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6201924" y="3373650"/>
              <a:ext cx="43910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. Attention Deficit Hyperactivity Disorder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6201924" y="493210"/>
              <a:ext cx="199285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. Panic Disorder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082379" y="6193907"/>
              <a:ext cx="22750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. Anxiety Disorders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092211" y="3426405"/>
              <a:ext cx="163378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. Depression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D5EFFDF-655B-4373-B886-60F0700AB9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09055" y="3795736"/>
              <a:ext cx="4300973" cy="2249463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78FB2B1-AA36-4B0B-AFDE-271997AA5F9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9317" y="6563239"/>
              <a:ext cx="4157788" cy="239817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D98372B-67EE-4487-91E9-753A44FE5E3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263" y="970185"/>
              <a:ext cx="4208842" cy="2339545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B533D0F7-48AB-40DF-A0DA-73B9B5E93F0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9317" y="3742981"/>
              <a:ext cx="4157788" cy="2468995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D7B4CF2C-09E4-4602-B6A6-4BD9B0AFCA9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55120" y="884514"/>
              <a:ext cx="4208842" cy="2439908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437471DC-DF9F-420D-A2B8-22C499D01D9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90477" y="6516513"/>
              <a:ext cx="4265615" cy="251510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994196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346C1D65-5A44-462E-96A8-7578D6CF9B16}"/>
              </a:ext>
            </a:extLst>
          </p:cNvPr>
          <p:cNvGrpSpPr/>
          <p:nvPr/>
        </p:nvGrpSpPr>
        <p:grpSpPr>
          <a:xfrm>
            <a:off x="400396" y="471238"/>
            <a:ext cx="10192538" cy="8579567"/>
            <a:chOff x="400396" y="471238"/>
            <a:chExt cx="10192538" cy="8579567"/>
          </a:xfrm>
        </p:grpSpPr>
        <p:sp>
          <p:nvSpPr>
            <p:cNvPr id="13" name="Rectangle 12"/>
            <p:cNvSpPr/>
            <p:nvPr/>
          </p:nvSpPr>
          <p:spPr>
            <a:xfrm>
              <a:off x="986042" y="471238"/>
              <a:ext cx="6096000" cy="369332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lvl="0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. Any Mental Health Condition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201924" y="6193907"/>
              <a:ext cx="363862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. Post-Traumatic Stress Disorder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6201924" y="3373650"/>
              <a:ext cx="43910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. Attention Deficit Hyperactivity Disorder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6201924" y="493210"/>
              <a:ext cx="199285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. Panic Disorder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082379" y="6193907"/>
              <a:ext cx="22750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. Anxiety Disorders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092211" y="3426405"/>
              <a:ext cx="163378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. Depression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E3CF5F7-471D-45B6-AA77-BC61AE8220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50198" y="3795737"/>
              <a:ext cx="4089157" cy="2359583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1EB92D2-3949-41B4-9A97-69054B85929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932" y="6563239"/>
              <a:ext cx="4388067" cy="248756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76AA030-4EC4-4F78-A395-D282E9B5B0C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0396" y="840570"/>
              <a:ext cx="4225290" cy="247817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56541009-43C7-44DC-ABC5-13F70A1B820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5170" y="3772634"/>
              <a:ext cx="4246545" cy="241555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C461929-D5A1-4DAD-BD45-F2A240949F8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6563239"/>
              <a:ext cx="4307760" cy="2474302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ACE6B593-8538-47C5-9D3D-C1CC592459C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67222" y="925126"/>
              <a:ext cx="4225290" cy="236181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06610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</TotalTime>
  <Words>159</Words>
  <Application>Microsoft Office PowerPoint</Application>
  <PresentationFormat>Custom</PresentationFormat>
  <Paragraphs>2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Chicago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iteerapong, Neda [BSD] - MED</dc:creator>
  <cp:lastModifiedBy>Neda Laiteerapong</cp:lastModifiedBy>
  <cp:revision>7</cp:revision>
  <dcterms:created xsi:type="dcterms:W3CDTF">2024-08-06T00:56:40Z</dcterms:created>
  <dcterms:modified xsi:type="dcterms:W3CDTF">2024-12-14T17:15:21Z</dcterms:modified>
</cp:coreProperties>
</file>